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7019925" cy="93059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20000" cy="930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3041640" cy="465120"/>
          </a:xfrm>
          <a:prstGeom prst="rect">
            <a:avLst/>
          </a:prstGeom>
          <a:noFill/>
          <a:ln w="0">
            <a:noFill/>
          </a:ln>
        </p:spPr>
        <p:txBody>
          <a:bodyPr lIns="88200" rIns="88200" tIns="44280" bIns="442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6200" y="0"/>
            <a:ext cx="3041640" cy="465120"/>
          </a:xfrm>
          <a:prstGeom prst="rect">
            <a:avLst/>
          </a:prstGeom>
          <a:noFill/>
          <a:ln w="0">
            <a:noFill/>
          </a:ln>
        </p:spPr>
        <p:txBody>
          <a:bodyPr lIns="88200" rIns="88200" tIns="44280" bIns="442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84400" y="698040"/>
            <a:ext cx="4651200" cy="3489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88200" rIns="88200" tIns="44280" bIns="44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640" y="4420800"/>
            <a:ext cx="5616720" cy="4186440"/>
          </a:xfrm>
          <a:prstGeom prst="rect">
            <a:avLst/>
          </a:prstGeom>
          <a:noFill/>
          <a:ln w="0">
            <a:noFill/>
          </a:ln>
        </p:spPr>
        <p:txBody>
          <a:bodyPr lIns="88200" rIns="88200" tIns="44280" bIns="442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839080"/>
            <a:ext cx="3041640" cy="465120"/>
          </a:xfrm>
          <a:prstGeom prst="rect">
            <a:avLst/>
          </a:prstGeom>
          <a:noFill/>
          <a:ln w="0">
            <a:noFill/>
          </a:ln>
        </p:spPr>
        <p:txBody>
          <a:bodyPr lIns="88200" rIns="88200" tIns="44280" bIns="44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6200" y="8839080"/>
            <a:ext cx="3041640" cy="465120"/>
          </a:xfrm>
          <a:prstGeom prst="rect">
            <a:avLst/>
          </a:prstGeom>
          <a:noFill/>
          <a:ln w="0">
            <a:noFill/>
          </a:ln>
        </p:spPr>
        <p:txBody>
          <a:bodyPr lIns="88200" rIns="88200" tIns="44280" bIns="4428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5DF751-73FF-4AA8-91B9-5FB62823EEF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sldImg"/>
          </p:nvPr>
        </p:nvSpPr>
        <p:spPr>
          <a:xfrm>
            <a:off x="1184400" y="698400"/>
            <a:ext cx="4651200" cy="3489480"/>
          </a:xfrm>
          <a:prstGeom prst="rect">
            <a:avLst/>
          </a:prstGeom>
          <a:ln w="0">
            <a:noFill/>
          </a:ln>
        </p:spPr>
      </p:sp>
      <p:sp>
        <p:nvSpPr>
          <p:cNvPr id="66" name="PlaceHolder 2"/>
          <p:cNvSpPr>
            <a:spLocks noGrp="1"/>
          </p:cNvSpPr>
          <p:nvPr>
            <p:ph type="body"/>
          </p:nvPr>
        </p:nvSpPr>
        <p:spPr>
          <a:xfrm>
            <a:off x="701640" y="4420800"/>
            <a:ext cx="5616720" cy="4186440"/>
          </a:xfrm>
          <a:prstGeom prst="rect">
            <a:avLst/>
          </a:prstGeom>
          <a:noFill/>
          <a:ln w="0">
            <a:noFill/>
          </a:ln>
        </p:spPr>
        <p:txBody>
          <a:bodyPr lIns="88200" rIns="88200" tIns="44280" bIns="442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. 1.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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can not block the suppression function of CD8+ NKT cells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eshly isolated C57BL/6 CD4+CD25- responder T cells were cultured in 96-well plates with anti-CD3 (1.5 ug/ml), irradiated splenic APCs (2000 rads), and different concentration of suppressive CD8+ NKT cells with or without indicated anti-TGFb antibody (5, 10 ug/ml) for 72 h. The cultures were pulsed with 0.5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i/ well [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]thymidine for the last 16 h of 72h culture and the level of proliferation was assessed by the [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]thymidine incorporation by scintillation counting after cell harvesting. The suppression effects value was then calculated according to the formula: % of suppression= (CPM value 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Tresp only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-CPM value 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Tresp+Treg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/ CPM value 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Tresp onl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lide Number Placeholder 3"/>
          <p:cNvSpPr/>
          <p:nvPr/>
        </p:nvSpPr>
        <p:spPr>
          <a:xfrm>
            <a:off x="3976560" y="8839080"/>
            <a:ext cx="304164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8200" rIns="88200" tIns="44280" bIns="4428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9727ED-EC19-4610-93AC-57FE83EE7B3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sldImg"/>
          </p:nvPr>
        </p:nvSpPr>
        <p:spPr>
          <a:xfrm>
            <a:off x="1184400" y="698400"/>
            <a:ext cx="4651200" cy="3489480"/>
          </a:xfrm>
          <a:prstGeom prst="rect">
            <a:avLst/>
          </a:prstGeom>
          <a:ln w="0">
            <a:noFill/>
          </a:ln>
        </p:spPr>
      </p:sp>
      <p:sp>
        <p:nvSpPr>
          <p:cNvPr id="69" name="PlaceHolder 2"/>
          <p:cNvSpPr>
            <a:spLocks noGrp="1"/>
          </p:cNvSpPr>
          <p:nvPr>
            <p:ph type="body"/>
          </p:nvPr>
        </p:nvSpPr>
        <p:spPr>
          <a:xfrm>
            <a:off x="701640" y="4420800"/>
            <a:ext cx="5616720" cy="4186440"/>
          </a:xfrm>
          <a:prstGeom prst="rect">
            <a:avLst/>
          </a:prstGeom>
          <a:noFill/>
          <a:ln w="0">
            <a:noFill/>
          </a:ln>
        </p:spPr>
        <p:txBody>
          <a:bodyPr lIns="88200" rIns="88200" tIns="44280" bIns="442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. 2. INFg restore the viability of in vitro cultured CD8+ T cells from INFg -/- mouse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Fg (10, 50ng/ml) was added to the CD8+ NKT cell culture (7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th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day culture) and cells were continuely cultured for additionally 24h. At the end of the culture, cells were harvested and cells viability was determined by the positivity for 7-AAD staining measured by flow cytometr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lide Number Placeholder 3"/>
          <p:cNvSpPr/>
          <p:nvPr/>
        </p:nvSpPr>
        <p:spPr>
          <a:xfrm>
            <a:off x="3976560" y="8839080"/>
            <a:ext cx="304164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8200" rIns="88200" tIns="44280" bIns="4428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8AEA90-6E05-42E6-9646-767631121A9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CAD79-E465-4A55-9CA1-EF805AEB22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D840AE-0722-413C-AB5D-99A74581A2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16423-9013-4106-8C04-30CAD62C79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3447C1-317C-45A4-88DA-47216FEA18E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A29A7-244C-494E-92EF-9389205CB0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51C492-2433-493E-8D38-4073F0BF42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05420-EF2F-45FB-9D5E-5C40BB6003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B01097-CF08-4B73-9CFA-3DA3785957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3A680-0295-469F-B48F-A4B229C397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C8357-7635-4C7D-97C2-BF15A3A00A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5DFE6-06F6-4733-9314-F304AA078F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AEDDDE-A746-41B4-B21F-59A5BB60E5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6ECE1D-D105-4A22-A5B5-5B00A48789C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"/>
          <p:cNvGrpSpPr/>
          <p:nvPr/>
        </p:nvGrpSpPr>
        <p:grpSpPr>
          <a:xfrm>
            <a:off x="1742400" y="990720"/>
            <a:ext cx="5191920" cy="3040200"/>
            <a:chOff x="1742400" y="990720"/>
            <a:chExt cx="5191920" cy="3040200"/>
          </a:xfrm>
        </p:grpSpPr>
        <p:pic>
          <p:nvPicPr>
            <p:cNvPr id="49" name="Chart 2" descr=""/>
            <p:cNvPicPr/>
            <p:nvPr/>
          </p:nvPicPr>
          <p:blipFill>
            <a:blip r:embed="rId1"/>
            <a:stretch/>
          </p:blipFill>
          <p:spPr>
            <a:xfrm>
              <a:off x="2340360" y="990720"/>
              <a:ext cx="4593960" cy="2356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Box 3"/>
            <p:cNvSpPr/>
            <p:nvPr/>
          </p:nvSpPr>
          <p:spPr>
            <a:xfrm rot="16200000">
              <a:off x="1487520" y="1962360"/>
              <a:ext cx="1418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% of Suppress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4"/>
            <p:cNvSpPr/>
            <p:nvPr/>
          </p:nvSpPr>
          <p:spPr>
            <a:xfrm>
              <a:off x="1742400" y="3314160"/>
              <a:ext cx="1162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-TGF</a:t>
              </a: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 (ug/ml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5"/>
            <p:cNvSpPr/>
            <p:nvPr/>
          </p:nvSpPr>
          <p:spPr>
            <a:xfrm>
              <a:off x="2883600" y="3314160"/>
              <a:ext cx="1543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0               5               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6"/>
            <p:cNvSpPr/>
            <p:nvPr/>
          </p:nvSpPr>
          <p:spPr>
            <a:xfrm>
              <a:off x="5181840" y="3314160"/>
              <a:ext cx="1543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0               5               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Straight Connector 7"/>
            <p:cNvSpPr/>
            <p:nvPr/>
          </p:nvSpPr>
          <p:spPr>
            <a:xfrm>
              <a:off x="2871000" y="3572640"/>
              <a:ext cx="148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Straight Connector 8"/>
            <p:cNvSpPr/>
            <p:nvPr/>
          </p:nvSpPr>
          <p:spPr>
            <a:xfrm>
              <a:off x="5230440" y="3572640"/>
              <a:ext cx="1478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0"/>
            <p:cNvSpPr/>
            <p:nvPr/>
          </p:nvSpPr>
          <p:spPr>
            <a:xfrm>
              <a:off x="3203280" y="3571920"/>
              <a:ext cx="712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Tr/Tres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1: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11"/>
            <p:cNvSpPr/>
            <p:nvPr/>
          </p:nvSpPr>
          <p:spPr>
            <a:xfrm>
              <a:off x="5644800" y="3571920"/>
              <a:ext cx="712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Tr/Tres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1: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" name="TextBox 12"/>
          <p:cNvSpPr/>
          <p:nvPr/>
        </p:nvSpPr>
        <p:spPr>
          <a:xfrm>
            <a:off x="708840" y="4419720"/>
            <a:ext cx="7956360" cy="16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: anti-TGF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cannot block the suppression function of CD8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NKT-like cell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eshly isolated C57BL/6 CD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D25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responder T cells were cultured in 96-well plates with anti-CD3 (1.5 ug/ml)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rradiated splenic APCs (2000 rads), and different concentration of suppressive CD8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NKT-like cells with or withou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dicated anti-TGF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tibody (5, 10 ug/ml) for 72 h. The cultures were pulsed with 0.5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i/ well [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]thymidine fo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last 16 h of 72h culture and the level of proliferation was assessed by the [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]thymidine incorporation by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cintillation counting after cell harvesting. The suppression effects value was then calculated according to th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ormula: % of suppression= (CPM value 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Tresp only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-CPM value 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Tresp+Treg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/ CPM value 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Tresp onl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Group 2"/>
          <p:cNvGrpSpPr/>
          <p:nvPr/>
        </p:nvGrpSpPr>
        <p:grpSpPr>
          <a:xfrm>
            <a:off x="2994480" y="685800"/>
            <a:ext cx="2787120" cy="2932560"/>
            <a:chOff x="2994480" y="685800"/>
            <a:chExt cx="2787120" cy="2932560"/>
          </a:xfrm>
        </p:grpSpPr>
        <p:sp>
          <p:nvSpPr>
            <p:cNvPr id="60" name="TextBox 3"/>
            <p:cNvSpPr/>
            <p:nvPr/>
          </p:nvSpPr>
          <p:spPr>
            <a:xfrm rot="16200000">
              <a:off x="2408040" y="1895760"/>
              <a:ext cx="1630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% of 7-AAD positiv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4"/>
            <p:cNvSpPr/>
            <p:nvPr/>
          </p:nvSpPr>
          <p:spPr>
            <a:xfrm>
              <a:off x="2994480" y="3219840"/>
              <a:ext cx="6044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NF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(ng/ml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5"/>
            <p:cNvSpPr/>
            <p:nvPr/>
          </p:nvSpPr>
          <p:spPr>
            <a:xfrm>
              <a:off x="3994200" y="3326040"/>
              <a:ext cx="1477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              10             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3" name="Chart 6" descr=""/>
            <p:cNvPicPr/>
            <p:nvPr/>
          </p:nvPicPr>
          <p:blipFill>
            <a:blip r:embed="rId1"/>
            <a:stretch/>
          </p:blipFill>
          <p:spPr>
            <a:xfrm>
              <a:off x="3345840" y="685800"/>
              <a:ext cx="2435760" cy="2703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4" name="TextBox 7"/>
          <p:cNvSpPr/>
          <p:nvPr/>
        </p:nvSpPr>
        <p:spPr>
          <a:xfrm>
            <a:off x="2362320" y="4038480"/>
            <a:ext cx="449568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2: INF-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restores the viability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in vitro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ultured CD8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NKT-like cells from INF-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-/-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ous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F-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10, 50ng/ml) was added to the CD8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 cell culture (7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th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day culture) and cells were further kept in culture for 24h. At the end of the culture, cells were harvested and cell viability was determined by the positivity for 7-AAD staining measured by flow cytometr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4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2-22T18:49:23Z</dcterms:created>
  <dc:creator>Li Zhou</dc:creator>
  <dc:description/>
  <dc:language>en-US</dc:language>
  <cp:lastModifiedBy>Jin-Xiong She</cp:lastModifiedBy>
  <dcterms:modified xsi:type="dcterms:W3CDTF">2008-07-25T20:12:06Z</dcterms:modified>
  <cp:revision>644</cp:revision>
  <dc:subject/>
  <dc:title>Slide 1</dc:title>
</cp:coreProperties>
</file>